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22" r:id="rId2"/>
    <p:sldId id="323" r:id="rId3"/>
    <p:sldId id="324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17" d="100"/>
          <a:sy n="117" d="100"/>
        </p:scale>
        <p:origin x="30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22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admanabh Singh" userId="5297dd9de2051429" providerId="LiveId" clId="{1E5F8D0C-68C3-4FC1-9B69-5B1D82998A2D}"/>
    <pc:docChg chg="undo custSel addSld delSld modSld sldOrd">
      <pc:chgData name="Padmanabh Singh" userId="5297dd9de2051429" providerId="LiveId" clId="{1E5F8D0C-68C3-4FC1-9B69-5B1D82998A2D}" dt="2023-12-15T06:35:07.537" v="678" actId="20577"/>
      <pc:docMkLst>
        <pc:docMk/>
      </pc:docMkLst>
      <pc:sldChg chg="addSp delSp modSp new mod">
        <pc:chgData name="Padmanabh Singh" userId="5297dd9de2051429" providerId="LiveId" clId="{1E5F8D0C-68C3-4FC1-9B69-5B1D82998A2D}" dt="2023-12-15T06:14:37.761" v="320" actId="478"/>
        <pc:sldMkLst>
          <pc:docMk/>
          <pc:sldMk cId="2528001082" sldId="256"/>
        </pc:sldMkLst>
        <pc:spChg chg="del">
          <ac:chgData name="Padmanabh Singh" userId="5297dd9de2051429" providerId="LiveId" clId="{1E5F8D0C-68C3-4FC1-9B69-5B1D82998A2D}" dt="2023-12-14T08:04:05.648" v="1" actId="478"/>
          <ac:spMkLst>
            <pc:docMk/>
            <pc:sldMk cId="2528001082" sldId="256"/>
            <ac:spMk id="2" creationId="{CA548570-D80E-4786-AD9A-9F8B6E0D15B5}"/>
          </ac:spMkLst>
        </pc:spChg>
        <pc:spChg chg="del">
          <ac:chgData name="Padmanabh Singh" userId="5297dd9de2051429" providerId="LiveId" clId="{1E5F8D0C-68C3-4FC1-9B69-5B1D82998A2D}" dt="2023-12-14T08:04:05.648" v="1" actId="478"/>
          <ac:spMkLst>
            <pc:docMk/>
            <pc:sldMk cId="2528001082" sldId="256"/>
            <ac:spMk id="3" creationId="{488526B0-4D69-48A5-9A28-0A72529FE52F}"/>
          </ac:spMkLst>
        </pc:spChg>
        <pc:spChg chg="add del mod">
          <ac:chgData name="Padmanabh Singh" userId="5297dd9de2051429" providerId="LiveId" clId="{1E5F8D0C-68C3-4FC1-9B69-5B1D82998A2D}" dt="2023-12-15T06:14:37.761" v="320" actId="478"/>
          <ac:spMkLst>
            <pc:docMk/>
            <pc:sldMk cId="2528001082" sldId="256"/>
            <ac:spMk id="5" creationId="{B57C5FAF-55B3-429D-B4DA-2CECAFF595F2}"/>
          </ac:spMkLst>
        </pc:spChg>
        <pc:graphicFrameChg chg="add mod">
          <ac:chgData name="Padmanabh Singh" userId="5297dd9de2051429" providerId="LiveId" clId="{1E5F8D0C-68C3-4FC1-9B69-5B1D82998A2D}" dt="2023-12-15T06:10:24.566" v="199" actId="1076"/>
          <ac:graphicFrameMkLst>
            <pc:docMk/>
            <pc:sldMk cId="2528001082" sldId="256"/>
            <ac:graphicFrameMk id="4" creationId="{EA360F17-CD36-4F80-9618-BE6D018EBFE1}"/>
          </ac:graphicFrameMkLst>
        </pc:graphicFrameChg>
        <pc:graphicFrameChg chg="add del mod">
          <ac:chgData name="Padmanabh Singh" userId="5297dd9de2051429" providerId="LiveId" clId="{1E5F8D0C-68C3-4FC1-9B69-5B1D82998A2D}" dt="2023-12-14T08:06:20.062" v="6" actId="478"/>
          <ac:graphicFrameMkLst>
            <pc:docMk/>
            <pc:sldMk cId="2528001082" sldId="256"/>
            <ac:graphicFrameMk id="5" creationId="{31968A10-64AC-484F-9F6E-F46CF43B6C9A}"/>
          </ac:graphicFrameMkLst>
        </pc:graphicFrameChg>
        <pc:graphicFrameChg chg="add mod">
          <ac:chgData name="Padmanabh Singh" userId="5297dd9de2051429" providerId="LiveId" clId="{1E5F8D0C-68C3-4FC1-9B69-5B1D82998A2D}" dt="2023-12-15T06:10:28.785" v="200" actId="1076"/>
          <ac:graphicFrameMkLst>
            <pc:docMk/>
            <pc:sldMk cId="2528001082" sldId="256"/>
            <ac:graphicFrameMk id="6" creationId="{02E6D997-70E3-4834-8661-2DBAABB6E1BF}"/>
          </ac:graphicFrameMkLst>
        </pc:graphicFrameChg>
        <pc:graphicFrameChg chg="add del mod">
          <ac:chgData name="Padmanabh Singh" userId="5297dd9de2051429" providerId="LiveId" clId="{1E5F8D0C-68C3-4FC1-9B69-5B1D82998A2D}" dt="2023-12-14T08:06:43.457" v="15"/>
          <ac:graphicFrameMkLst>
            <pc:docMk/>
            <pc:sldMk cId="2528001082" sldId="256"/>
            <ac:graphicFrameMk id="6" creationId="{62F2A14B-9290-4C7D-99D9-016801250809}"/>
          </ac:graphicFrameMkLst>
        </pc:graphicFrameChg>
        <pc:graphicFrameChg chg="add mod">
          <ac:chgData name="Padmanabh Singh" userId="5297dd9de2051429" providerId="LiveId" clId="{1E5F8D0C-68C3-4FC1-9B69-5B1D82998A2D}" dt="2023-12-15T06:10:31.270" v="201" actId="1076"/>
          <ac:graphicFrameMkLst>
            <pc:docMk/>
            <pc:sldMk cId="2528001082" sldId="256"/>
            <ac:graphicFrameMk id="7" creationId="{7D2256B6-2341-4391-8975-E37F4663E991}"/>
          </ac:graphicFrameMkLst>
        </pc:graphicFrameChg>
      </pc:sldChg>
      <pc:sldChg chg="addSp delSp modSp new mod">
        <pc:chgData name="Padmanabh Singh" userId="5297dd9de2051429" providerId="LiveId" clId="{1E5F8D0C-68C3-4FC1-9B69-5B1D82998A2D}" dt="2023-12-15T06:29:49.251" v="603" actId="1076"/>
        <pc:sldMkLst>
          <pc:docMk/>
          <pc:sldMk cId="3713618127" sldId="257"/>
        </pc:sldMkLst>
        <pc:spChg chg="add mod">
          <ac:chgData name="Padmanabh Singh" userId="5297dd9de2051429" providerId="LiveId" clId="{1E5F8D0C-68C3-4FC1-9B69-5B1D82998A2D}" dt="2023-12-15T06:29:49.251" v="603" actId="1076"/>
          <ac:spMkLst>
            <pc:docMk/>
            <pc:sldMk cId="3713618127" sldId="257"/>
            <ac:spMk id="2" creationId="{25E65260-A873-46F0-9969-5817AB375A83}"/>
          </ac:spMkLst>
        </pc:spChg>
        <pc:spChg chg="del">
          <ac:chgData name="Padmanabh Singh" userId="5297dd9de2051429" providerId="LiveId" clId="{1E5F8D0C-68C3-4FC1-9B69-5B1D82998A2D}" dt="2023-12-14T08:06:26.105" v="8" actId="478"/>
          <ac:spMkLst>
            <pc:docMk/>
            <pc:sldMk cId="3713618127" sldId="257"/>
            <ac:spMk id="2" creationId="{3DC6F618-0B9E-4BFE-91DF-1C80F955D654}"/>
          </ac:spMkLst>
        </pc:spChg>
        <pc:spChg chg="del">
          <ac:chgData name="Padmanabh Singh" userId="5297dd9de2051429" providerId="LiveId" clId="{1E5F8D0C-68C3-4FC1-9B69-5B1D82998A2D}" dt="2023-12-14T08:06:26.105" v="8" actId="478"/>
          <ac:spMkLst>
            <pc:docMk/>
            <pc:sldMk cId="3713618127" sldId="257"/>
            <ac:spMk id="3" creationId="{0CA8FC88-D5DA-49CF-A73D-C3EB0B1D0689}"/>
          </ac:spMkLst>
        </pc:spChg>
        <pc:spChg chg="add mod">
          <ac:chgData name="Padmanabh Singh" userId="5297dd9de2051429" providerId="LiveId" clId="{1E5F8D0C-68C3-4FC1-9B69-5B1D82998A2D}" dt="2023-12-15T06:28:35.023" v="535" actId="1076"/>
          <ac:spMkLst>
            <pc:docMk/>
            <pc:sldMk cId="3713618127" sldId="257"/>
            <ac:spMk id="7" creationId="{5A215FBC-8D6F-4683-B2EB-40AF09AA5165}"/>
          </ac:spMkLst>
        </pc:spChg>
        <pc:graphicFrameChg chg="add del mod">
          <ac:chgData name="Padmanabh Singh" userId="5297dd9de2051429" providerId="LiveId" clId="{1E5F8D0C-68C3-4FC1-9B69-5B1D82998A2D}" dt="2023-12-14T08:08:00.632" v="29" actId="1076"/>
          <ac:graphicFrameMkLst>
            <pc:docMk/>
            <pc:sldMk cId="3713618127" sldId="257"/>
            <ac:graphicFrameMk id="4" creationId="{137CC9ED-74E3-4FE4-B27A-7B8EE5672A2F}"/>
          </ac:graphicFrameMkLst>
        </pc:graphicFrameChg>
        <pc:graphicFrameChg chg="add mod">
          <ac:chgData name="Padmanabh Singh" userId="5297dd9de2051429" providerId="LiveId" clId="{1E5F8D0C-68C3-4FC1-9B69-5B1D82998A2D}" dt="2023-12-14T08:08:04.458" v="30" actId="1076"/>
          <ac:graphicFrameMkLst>
            <pc:docMk/>
            <pc:sldMk cId="3713618127" sldId="257"/>
            <ac:graphicFrameMk id="5" creationId="{1336307F-4D07-4A88-9B00-E893C6156782}"/>
          </ac:graphicFrameMkLst>
        </pc:graphicFrameChg>
        <pc:graphicFrameChg chg="add mod">
          <ac:chgData name="Padmanabh Singh" userId="5297dd9de2051429" providerId="LiveId" clId="{1E5F8D0C-68C3-4FC1-9B69-5B1D82998A2D}" dt="2023-12-14T08:08:10.901" v="32" actId="1076"/>
          <ac:graphicFrameMkLst>
            <pc:docMk/>
            <pc:sldMk cId="3713618127" sldId="257"/>
            <ac:graphicFrameMk id="6" creationId="{4CCD40B6-4B70-46B8-A375-CD7A010C8CD8}"/>
          </ac:graphicFrameMkLst>
        </pc:graphicFrameChg>
        <pc:graphicFrameChg chg="add del mod">
          <ac:chgData name="Padmanabh Singh" userId="5297dd9de2051429" providerId="LiveId" clId="{1E5F8D0C-68C3-4FC1-9B69-5B1D82998A2D}" dt="2023-12-14T22:18:22.926" v="68" actId="478"/>
          <ac:graphicFrameMkLst>
            <pc:docMk/>
            <pc:sldMk cId="3713618127" sldId="257"/>
            <ac:graphicFrameMk id="7" creationId="{B98013D7-D5A3-4152-8D30-BE3DAC257F96}"/>
          </ac:graphicFrameMkLst>
        </pc:graphicFrameChg>
      </pc:sldChg>
      <pc:sldChg chg="addSp delSp modSp new mod">
        <pc:chgData name="Padmanabh Singh" userId="5297dd9de2051429" providerId="LiveId" clId="{1E5F8D0C-68C3-4FC1-9B69-5B1D82998A2D}" dt="2023-12-15T06:33:10.480" v="651" actId="20577"/>
        <pc:sldMkLst>
          <pc:docMk/>
          <pc:sldMk cId="3634488272" sldId="258"/>
        </pc:sldMkLst>
        <pc:spChg chg="del">
          <ac:chgData name="Padmanabh Singh" userId="5297dd9de2051429" providerId="LiveId" clId="{1E5F8D0C-68C3-4FC1-9B69-5B1D82998A2D}" dt="2023-12-14T08:06:50.421" v="18" actId="478"/>
          <ac:spMkLst>
            <pc:docMk/>
            <pc:sldMk cId="3634488272" sldId="258"/>
            <ac:spMk id="2" creationId="{3954335D-7AC5-447C-BCB0-D41C1EA5CC5F}"/>
          </ac:spMkLst>
        </pc:spChg>
        <pc:spChg chg="del">
          <ac:chgData name="Padmanabh Singh" userId="5297dd9de2051429" providerId="LiveId" clId="{1E5F8D0C-68C3-4FC1-9B69-5B1D82998A2D}" dt="2023-12-14T08:06:50.421" v="18" actId="478"/>
          <ac:spMkLst>
            <pc:docMk/>
            <pc:sldMk cId="3634488272" sldId="258"/>
            <ac:spMk id="3" creationId="{20B9D53E-8010-473A-AB57-F22F19067636}"/>
          </ac:spMkLst>
        </pc:spChg>
        <pc:spChg chg="add mod">
          <ac:chgData name="Padmanabh Singh" userId="5297dd9de2051429" providerId="LiveId" clId="{1E5F8D0C-68C3-4FC1-9B69-5B1D82998A2D}" dt="2023-12-15T06:31:19.992" v="622" actId="1076"/>
          <ac:spMkLst>
            <pc:docMk/>
            <pc:sldMk cId="3634488272" sldId="258"/>
            <ac:spMk id="4" creationId="{13146732-AFBC-4413-B31A-7674108CC701}"/>
          </ac:spMkLst>
        </pc:spChg>
        <pc:spChg chg="add mod">
          <ac:chgData name="Padmanabh Singh" userId="5297dd9de2051429" providerId="LiveId" clId="{1E5F8D0C-68C3-4FC1-9B69-5B1D82998A2D}" dt="2023-12-15T06:33:10.480" v="651" actId="20577"/>
          <ac:spMkLst>
            <pc:docMk/>
            <pc:sldMk cId="3634488272" sldId="258"/>
            <ac:spMk id="5" creationId="{2755D0F1-20A4-4A66-AF55-B45AB7BF568D}"/>
          </ac:spMkLst>
        </pc:spChg>
        <pc:graphicFrameChg chg="add del mod">
          <ac:chgData name="Padmanabh Singh" userId="5297dd9de2051429" providerId="LiveId" clId="{1E5F8D0C-68C3-4FC1-9B69-5B1D82998A2D}" dt="2023-12-14T08:07:57.306" v="28" actId="21"/>
          <ac:graphicFrameMkLst>
            <pc:docMk/>
            <pc:sldMk cId="3634488272" sldId="258"/>
            <ac:graphicFrameMk id="4" creationId="{A7E86584-CEB3-4E7E-860E-2703A38EF282}"/>
          </ac:graphicFrameMkLst>
        </pc:graphicFrameChg>
        <pc:graphicFrameChg chg="add del mod">
          <ac:chgData name="Padmanabh Singh" userId="5297dd9de2051429" providerId="LiveId" clId="{1E5F8D0C-68C3-4FC1-9B69-5B1D82998A2D}" dt="2023-12-14T08:10:28.562" v="34" actId="478"/>
          <ac:graphicFrameMkLst>
            <pc:docMk/>
            <pc:sldMk cId="3634488272" sldId="258"/>
            <ac:graphicFrameMk id="5" creationId="{7568BD1E-4F1F-4FD2-95BE-92CCECC87B0D}"/>
          </ac:graphicFrameMkLst>
        </pc:graphicFrameChg>
        <pc:graphicFrameChg chg="add mod">
          <ac:chgData name="Padmanabh Singh" userId="5297dd9de2051429" providerId="LiveId" clId="{1E5F8D0C-68C3-4FC1-9B69-5B1D82998A2D}" dt="2023-12-14T08:10:36.391" v="36" actId="1076"/>
          <ac:graphicFrameMkLst>
            <pc:docMk/>
            <pc:sldMk cId="3634488272" sldId="258"/>
            <ac:graphicFrameMk id="6" creationId="{E7B34450-8654-44E0-9543-A1670ADD6799}"/>
          </ac:graphicFrameMkLst>
        </pc:graphicFrameChg>
        <pc:graphicFrameChg chg="add mod">
          <ac:chgData name="Padmanabh Singh" userId="5297dd9de2051429" providerId="LiveId" clId="{1E5F8D0C-68C3-4FC1-9B69-5B1D82998A2D}" dt="2023-12-14T08:11:40.191" v="38" actId="1076"/>
          <ac:graphicFrameMkLst>
            <pc:docMk/>
            <pc:sldMk cId="3634488272" sldId="258"/>
            <ac:graphicFrameMk id="7" creationId="{717B7F99-18D1-4DBB-AE6A-0A4F1FA5CB3F}"/>
          </ac:graphicFrameMkLst>
        </pc:graphicFrameChg>
      </pc:sldChg>
      <pc:sldChg chg="addSp delSp modSp add mod">
        <pc:chgData name="Padmanabh Singh" userId="5297dd9de2051429" providerId="LiveId" clId="{1E5F8D0C-68C3-4FC1-9B69-5B1D82998A2D}" dt="2023-12-15T06:34:28.085" v="668" actId="20577"/>
        <pc:sldMkLst>
          <pc:docMk/>
          <pc:sldMk cId="794722348" sldId="259"/>
        </pc:sldMkLst>
        <pc:spChg chg="mod">
          <ac:chgData name="Padmanabh Singh" userId="5297dd9de2051429" providerId="LiveId" clId="{1E5F8D0C-68C3-4FC1-9B69-5B1D82998A2D}" dt="2023-12-15T00:25:54.540" v="123"/>
          <ac:spMkLst>
            <pc:docMk/>
            <pc:sldMk cId="794722348" sldId="259"/>
            <ac:spMk id="8" creationId="{8A5ADE3E-DC7B-49FD-ADE9-67E55887F2D2}"/>
          </ac:spMkLst>
        </pc:spChg>
        <pc:spChg chg="mod">
          <ac:chgData name="Padmanabh Singh" userId="5297dd9de2051429" providerId="LiveId" clId="{1E5F8D0C-68C3-4FC1-9B69-5B1D82998A2D}" dt="2023-12-15T00:25:54.540" v="123"/>
          <ac:spMkLst>
            <pc:docMk/>
            <pc:sldMk cId="794722348" sldId="259"/>
            <ac:spMk id="9" creationId="{FF128BC0-B9F7-4448-82A7-68BB2463A661}"/>
          </ac:spMkLst>
        </pc:spChg>
        <pc:spChg chg="mod">
          <ac:chgData name="Padmanabh Singh" userId="5297dd9de2051429" providerId="LiveId" clId="{1E5F8D0C-68C3-4FC1-9B69-5B1D82998A2D}" dt="2023-12-15T00:25:54.540" v="123"/>
          <ac:spMkLst>
            <pc:docMk/>
            <pc:sldMk cId="794722348" sldId="259"/>
            <ac:spMk id="10" creationId="{03FABC8A-EB8D-4E76-AA17-638B50571AE9}"/>
          </ac:spMkLst>
        </pc:spChg>
        <pc:spChg chg="mod">
          <ac:chgData name="Padmanabh Singh" userId="5297dd9de2051429" providerId="LiveId" clId="{1E5F8D0C-68C3-4FC1-9B69-5B1D82998A2D}" dt="2023-12-15T00:25:54.540" v="123"/>
          <ac:spMkLst>
            <pc:docMk/>
            <pc:sldMk cId="794722348" sldId="259"/>
            <ac:spMk id="11" creationId="{620F842A-9534-459F-801C-7439EE6C6760}"/>
          </ac:spMkLst>
        </pc:spChg>
        <pc:spChg chg="mod">
          <ac:chgData name="Padmanabh Singh" userId="5297dd9de2051429" providerId="LiveId" clId="{1E5F8D0C-68C3-4FC1-9B69-5B1D82998A2D}" dt="2023-12-15T00:25:54.540" v="123"/>
          <ac:spMkLst>
            <pc:docMk/>
            <pc:sldMk cId="794722348" sldId="259"/>
            <ac:spMk id="12" creationId="{A64F8A95-EE31-4A9B-BDF9-AACCDE9BF406}"/>
          </ac:spMkLst>
        </pc:spChg>
        <pc:spChg chg="add mod">
          <ac:chgData name="Padmanabh Singh" userId="5297dd9de2051429" providerId="LiveId" clId="{1E5F8D0C-68C3-4FC1-9B69-5B1D82998A2D}" dt="2023-12-15T06:33:45.168" v="655" actId="1076"/>
          <ac:spMkLst>
            <pc:docMk/>
            <pc:sldMk cId="794722348" sldId="259"/>
            <ac:spMk id="13" creationId="{8C308AEB-EC85-4562-B6F8-2802E617F1BD}"/>
          </ac:spMkLst>
        </pc:spChg>
        <pc:spChg chg="add mod">
          <ac:chgData name="Padmanabh Singh" userId="5297dd9de2051429" providerId="LiveId" clId="{1E5F8D0C-68C3-4FC1-9B69-5B1D82998A2D}" dt="2023-12-15T06:34:28.085" v="668" actId="20577"/>
          <ac:spMkLst>
            <pc:docMk/>
            <pc:sldMk cId="794722348" sldId="259"/>
            <ac:spMk id="14" creationId="{FBBFA81E-27BF-4CF9-9F26-860B44E10DC6}"/>
          </ac:spMkLst>
        </pc:spChg>
        <pc:grpChg chg="add mod">
          <ac:chgData name="Padmanabh Singh" userId="5297dd9de2051429" providerId="LiveId" clId="{1E5F8D0C-68C3-4FC1-9B69-5B1D82998A2D}" dt="2023-12-15T00:26:46.207" v="128" actId="1076"/>
          <ac:grpSpMkLst>
            <pc:docMk/>
            <pc:sldMk cId="794722348" sldId="259"/>
            <ac:grpSpMk id="6" creationId="{D368DF93-DCF9-42CB-8670-8B7BC22EA79E}"/>
          </ac:grpSpMkLst>
        </pc:grpChg>
        <pc:graphicFrameChg chg="add mod">
          <ac:chgData name="Padmanabh Singh" userId="5297dd9de2051429" providerId="LiveId" clId="{1E5F8D0C-68C3-4FC1-9B69-5B1D82998A2D}" dt="2023-12-15T06:33:42.324" v="654" actId="1076"/>
          <ac:graphicFrameMkLst>
            <pc:docMk/>
            <pc:sldMk cId="794722348" sldId="259"/>
            <ac:graphicFrameMk id="2" creationId="{155238F3-7D58-4DEA-AFE2-BC196900C84E}"/>
          </ac:graphicFrameMkLst>
        </pc:graphicFrameChg>
        <pc:graphicFrameChg chg="add del mod">
          <ac:chgData name="Padmanabh Singh" userId="5297dd9de2051429" providerId="LiveId" clId="{1E5F8D0C-68C3-4FC1-9B69-5B1D82998A2D}" dt="2023-12-14T08:15:56.365" v="41" actId="478"/>
          <ac:graphicFrameMkLst>
            <pc:docMk/>
            <pc:sldMk cId="794722348" sldId="259"/>
            <ac:graphicFrameMk id="2" creationId="{68A4FEF8-2EC2-4667-B97E-F1B5E69F7D7D}"/>
          </ac:graphicFrameMkLst>
        </pc:graphicFrameChg>
        <pc:graphicFrameChg chg="add mod">
          <ac:chgData name="Padmanabh Singh" userId="5297dd9de2051429" providerId="LiveId" clId="{1E5F8D0C-68C3-4FC1-9B69-5B1D82998A2D}" dt="2023-12-15T06:33:42.324" v="654" actId="1076"/>
          <ac:graphicFrameMkLst>
            <pc:docMk/>
            <pc:sldMk cId="794722348" sldId="259"/>
            <ac:graphicFrameMk id="3" creationId="{A92C6647-75A5-49D6-BD8D-112F79552E2F}"/>
          </ac:graphicFrameMkLst>
        </pc:graphicFrameChg>
        <pc:graphicFrameChg chg="add del mod">
          <ac:chgData name="Padmanabh Singh" userId="5297dd9de2051429" providerId="LiveId" clId="{1E5F8D0C-68C3-4FC1-9B69-5B1D82998A2D}" dt="2023-12-14T08:16:54.371" v="51" actId="478"/>
          <ac:graphicFrameMkLst>
            <pc:docMk/>
            <pc:sldMk cId="794722348" sldId="259"/>
            <ac:graphicFrameMk id="4" creationId="{14DF24B2-A366-47EB-8B21-274258ADDB56}"/>
          </ac:graphicFrameMkLst>
        </pc:graphicFrameChg>
        <pc:picChg chg="add del mod modCrop">
          <ac:chgData name="Padmanabh Singh" userId="5297dd9de2051429" providerId="LiveId" clId="{1E5F8D0C-68C3-4FC1-9B69-5B1D82998A2D}" dt="2023-12-15T00:25:52.541" v="122" actId="478"/>
          <ac:picMkLst>
            <pc:docMk/>
            <pc:sldMk cId="794722348" sldId="259"/>
            <ac:picMk id="5" creationId="{4CEF466E-944E-4AFD-A690-475B41960DCD}"/>
          </ac:picMkLst>
        </pc:picChg>
        <pc:picChg chg="mod">
          <ac:chgData name="Padmanabh Singh" userId="5297dd9de2051429" providerId="LiveId" clId="{1E5F8D0C-68C3-4FC1-9B69-5B1D82998A2D}" dt="2023-12-15T00:25:54.540" v="123"/>
          <ac:picMkLst>
            <pc:docMk/>
            <pc:sldMk cId="794722348" sldId="259"/>
            <ac:picMk id="7" creationId="{774BFA93-9F4E-4D51-9F7E-5088574F0E34}"/>
          </ac:picMkLst>
        </pc:picChg>
      </pc:sldChg>
      <pc:sldChg chg="addSp modSp add del mod ord">
        <pc:chgData name="Padmanabh Singh" userId="5297dd9de2051429" providerId="LiveId" clId="{1E5F8D0C-68C3-4FC1-9B69-5B1D82998A2D}" dt="2023-12-15T06:14:41.089" v="321" actId="47"/>
        <pc:sldMkLst>
          <pc:docMk/>
          <pc:sldMk cId="586082648" sldId="260"/>
        </pc:sldMkLst>
        <pc:spChg chg="add mod">
          <ac:chgData name="Padmanabh Singh" userId="5297dd9de2051429" providerId="LiveId" clId="{1E5F8D0C-68C3-4FC1-9B69-5B1D82998A2D}" dt="2023-12-15T00:27:42.581" v="132" actId="1076"/>
          <ac:spMkLst>
            <pc:docMk/>
            <pc:sldMk cId="586082648" sldId="260"/>
            <ac:spMk id="3" creationId="{3AF4D33A-3BDE-4384-A69E-5D6D51F12E2D}"/>
          </ac:spMkLst>
        </pc:spChg>
        <pc:graphicFrameChg chg="add mod">
          <ac:chgData name="Padmanabh Singh" userId="5297dd9de2051429" providerId="LiveId" clId="{1E5F8D0C-68C3-4FC1-9B69-5B1D82998A2D}" dt="2023-12-14T22:17:15.085" v="63" actId="1076"/>
          <ac:graphicFrameMkLst>
            <pc:docMk/>
            <pc:sldMk cId="586082648" sldId="260"/>
            <ac:graphicFrameMk id="2" creationId="{2090EFE3-3028-4298-965C-4E542CE8ED3F}"/>
          </ac:graphicFrameMkLst>
        </pc:graphicFrameChg>
      </pc:sldChg>
      <pc:sldChg chg="addSp modSp add mod ord">
        <pc:chgData name="Padmanabh Singh" userId="5297dd9de2051429" providerId="LiveId" clId="{1E5F8D0C-68C3-4FC1-9B69-5B1D82998A2D}" dt="2023-12-15T06:30:22.967" v="616" actId="20577"/>
        <pc:sldMkLst>
          <pc:docMk/>
          <pc:sldMk cId="360537094" sldId="261"/>
        </pc:sldMkLst>
        <pc:spChg chg="add mod">
          <ac:chgData name="Padmanabh Singh" userId="5297dd9de2051429" providerId="LiveId" clId="{1E5F8D0C-68C3-4FC1-9B69-5B1D82998A2D}" dt="2023-12-15T06:29:59.406" v="604" actId="1076"/>
          <ac:spMkLst>
            <pc:docMk/>
            <pc:sldMk cId="360537094" sldId="261"/>
            <ac:spMk id="5" creationId="{85A963A9-C413-4A4C-AA12-A9F1A552BEC1}"/>
          </ac:spMkLst>
        </pc:spChg>
        <pc:spChg chg="add mod">
          <ac:chgData name="Padmanabh Singh" userId="5297dd9de2051429" providerId="LiveId" clId="{1E5F8D0C-68C3-4FC1-9B69-5B1D82998A2D}" dt="2023-12-15T06:30:22.967" v="616" actId="20577"/>
          <ac:spMkLst>
            <pc:docMk/>
            <pc:sldMk cId="360537094" sldId="261"/>
            <ac:spMk id="6" creationId="{F12AF558-368D-4060-BEEA-DCE3EB041F4E}"/>
          </ac:spMkLst>
        </pc:spChg>
        <pc:graphicFrameChg chg="add mod">
          <ac:chgData name="Padmanabh Singh" userId="5297dd9de2051429" providerId="LiveId" clId="{1E5F8D0C-68C3-4FC1-9B69-5B1D82998A2D}" dt="2023-12-14T22:19:21.706" v="72" actId="1076"/>
          <ac:graphicFrameMkLst>
            <pc:docMk/>
            <pc:sldMk cId="360537094" sldId="261"/>
            <ac:graphicFrameMk id="2" creationId="{AC9093FB-0A62-42B0-8082-1345F6D278F5}"/>
          </ac:graphicFrameMkLst>
        </pc:graphicFrameChg>
        <pc:graphicFrameChg chg="add mod">
          <ac:chgData name="Padmanabh Singh" userId="5297dd9de2051429" providerId="LiveId" clId="{1E5F8D0C-68C3-4FC1-9B69-5B1D82998A2D}" dt="2023-12-14T22:19:17.691" v="71" actId="1076"/>
          <ac:graphicFrameMkLst>
            <pc:docMk/>
            <pc:sldMk cId="360537094" sldId="261"/>
            <ac:graphicFrameMk id="3" creationId="{EADF0835-EDFF-41FF-890A-5AD398255736}"/>
          </ac:graphicFrameMkLst>
        </pc:graphicFrameChg>
        <pc:graphicFrameChg chg="add mod">
          <ac:chgData name="Padmanabh Singh" userId="5297dd9de2051429" providerId="LiveId" clId="{1E5F8D0C-68C3-4FC1-9B69-5B1D82998A2D}" dt="2023-12-14T22:19:58.737" v="74" actId="1076"/>
          <ac:graphicFrameMkLst>
            <pc:docMk/>
            <pc:sldMk cId="360537094" sldId="261"/>
            <ac:graphicFrameMk id="4" creationId="{9B4E9D67-9B06-4FCD-A792-2F18743CEB41}"/>
          </ac:graphicFrameMkLst>
        </pc:graphicFrameChg>
      </pc:sldChg>
      <pc:sldChg chg="addSp modSp add mod ord">
        <pc:chgData name="Padmanabh Singh" userId="5297dd9de2051429" providerId="LiveId" clId="{1E5F8D0C-68C3-4FC1-9B69-5B1D82998A2D}" dt="2023-12-15T06:32:31.670" v="649" actId="20577"/>
        <pc:sldMkLst>
          <pc:docMk/>
          <pc:sldMk cId="3589399313" sldId="262"/>
        </pc:sldMkLst>
        <pc:spChg chg="add mod">
          <ac:chgData name="Padmanabh Singh" userId="5297dd9de2051429" providerId="LiveId" clId="{1E5F8D0C-68C3-4FC1-9B69-5B1D82998A2D}" dt="2023-12-15T06:32:01.854" v="639" actId="1076"/>
          <ac:spMkLst>
            <pc:docMk/>
            <pc:sldMk cId="3589399313" sldId="262"/>
            <ac:spMk id="4" creationId="{96881F8A-A505-4EAB-AAD2-7376A96A85E8}"/>
          </ac:spMkLst>
        </pc:spChg>
        <pc:spChg chg="add mod">
          <ac:chgData name="Padmanabh Singh" userId="5297dd9de2051429" providerId="LiveId" clId="{1E5F8D0C-68C3-4FC1-9B69-5B1D82998A2D}" dt="2023-12-15T06:32:31.670" v="649" actId="20577"/>
          <ac:spMkLst>
            <pc:docMk/>
            <pc:sldMk cId="3589399313" sldId="262"/>
            <ac:spMk id="5" creationId="{001521B3-AC43-49DD-894F-B9231049AC4F}"/>
          </ac:spMkLst>
        </pc:spChg>
        <pc:graphicFrameChg chg="add mod">
          <ac:chgData name="Padmanabh Singh" userId="5297dd9de2051429" providerId="LiveId" clId="{1E5F8D0C-68C3-4FC1-9B69-5B1D82998A2D}" dt="2023-12-14T22:20:27.611" v="76" actId="1076"/>
          <ac:graphicFrameMkLst>
            <pc:docMk/>
            <pc:sldMk cId="3589399313" sldId="262"/>
            <ac:graphicFrameMk id="2" creationId="{A8430542-05D6-4D9E-BFD8-8BF874079E88}"/>
          </ac:graphicFrameMkLst>
        </pc:graphicFrameChg>
        <pc:graphicFrameChg chg="add mod">
          <ac:chgData name="Padmanabh Singh" userId="5297dd9de2051429" providerId="LiveId" clId="{1E5F8D0C-68C3-4FC1-9B69-5B1D82998A2D}" dt="2023-12-14T22:20:52.861" v="78" actId="1076"/>
          <ac:graphicFrameMkLst>
            <pc:docMk/>
            <pc:sldMk cId="3589399313" sldId="262"/>
            <ac:graphicFrameMk id="3" creationId="{ECD8C836-2F96-4B84-A1D2-6121CF9E28D6}"/>
          </ac:graphicFrameMkLst>
        </pc:graphicFrameChg>
      </pc:sldChg>
      <pc:sldChg chg="addSp delSp modSp add mod">
        <pc:chgData name="Padmanabh Singh" userId="5297dd9de2051429" providerId="LiveId" clId="{1E5F8D0C-68C3-4FC1-9B69-5B1D82998A2D}" dt="2023-12-15T06:34:43.382" v="672" actId="20577"/>
        <pc:sldMkLst>
          <pc:docMk/>
          <pc:sldMk cId="1797960873" sldId="263"/>
        </pc:sldMkLst>
        <pc:spChg chg="mod">
          <ac:chgData name="Padmanabh Singh" userId="5297dd9de2051429" providerId="LiveId" clId="{1E5F8D0C-68C3-4FC1-9B69-5B1D82998A2D}" dt="2023-12-15T00:29:27.826" v="143"/>
          <ac:spMkLst>
            <pc:docMk/>
            <pc:sldMk cId="1797960873" sldId="263"/>
            <ac:spMk id="7" creationId="{D2133969-C49D-4431-ACEB-F9F0D1904186}"/>
          </ac:spMkLst>
        </pc:spChg>
        <pc:spChg chg="mod">
          <ac:chgData name="Padmanabh Singh" userId="5297dd9de2051429" providerId="LiveId" clId="{1E5F8D0C-68C3-4FC1-9B69-5B1D82998A2D}" dt="2023-12-15T00:29:27.826" v="143"/>
          <ac:spMkLst>
            <pc:docMk/>
            <pc:sldMk cId="1797960873" sldId="263"/>
            <ac:spMk id="8" creationId="{38E02FDC-8390-4D6C-885D-89ECCDD926C6}"/>
          </ac:spMkLst>
        </pc:spChg>
        <pc:spChg chg="mod">
          <ac:chgData name="Padmanabh Singh" userId="5297dd9de2051429" providerId="LiveId" clId="{1E5F8D0C-68C3-4FC1-9B69-5B1D82998A2D}" dt="2023-12-15T00:29:27.826" v="143"/>
          <ac:spMkLst>
            <pc:docMk/>
            <pc:sldMk cId="1797960873" sldId="263"/>
            <ac:spMk id="9" creationId="{1DB37669-A613-423F-A322-9B30BF4FB499}"/>
          </ac:spMkLst>
        </pc:spChg>
        <pc:spChg chg="mod">
          <ac:chgData name="Padmanabh Singh" userId="5297dd9de2051429" providerId="LiveId" clId="{1E5F8D0C-68C3-4FC1-9B69-5B1D82998A2D}" dt="2023-12-15T00:29:27.826" v="143"/>
          <ac:spMkLst>
            <pc:docMk/>
            <pc:sldMk cId="1797960873" sldId="263"/>
            <ac:spMk id="10" creationId="{9B1C4732-20D3-4783-B53F-2EFD98BFDA81}"/>
          </ac:spMkLst>
        </pc:spChg>
        <pc:spChg chg="mod">
          <ac:chgData name="Padmanabh Singh" userId="5297dd9de2051429" providerId="LiveId" clId="{1E5F8D0C-68C3-4FC1-9B69-5B1D82998A2D}" dt="2023-12-15T00:29:27.826" v="143"/>
          <ac:spMkLst>
            <pc:docMk/>
            <pc:sldMk cId="1797960873" sldId="263"/>
            <ac:spMk id="11" creationId="{68E9785A-F472-43CB-848B-60B5BD585A68}"/>
          </ac:spMkLst>
        </pc:spChg>
        <pc:spChg chg="add mod">
          <ac:chgData name="Padmanabh Singh" userId="5297dd9de2051429" providerId="LiveId" clId="{1E5F8D0C-68C3-4FC1-9B69-5B1D82998A2D}" dt="2023-12-15T06:34:31.819" v="669" actId="1076"/>
          <ac:spMkLst>
            <pc:docMk/>
            <pc:sldMk cId="1797960873" sldId="263"/>
            <ac:spMk id="12" creationId="{D16BD198-6594-49FF-AC40-B25F9C70FB87}"/>
          </ac:spMkLst>
        </pc:spChg>
        <pc:spChg chg="add mod">
          <ac:chgData name="Padmanabh Singh" userId="5297dd9de2051429" providerId="LiveId" clId="{1E5F8D0C-68C3-4FC1-9B69-5B1D82998A2D}" dt="2023-12-15T06:34:43.382" v="672" actId="20577"/>
          <ac:spMkLst>
            <pc:docMk/>
            <pc:sldMk cId="1797960873" sldId="263"/>
            <ac:spMk id="13" creationId="{B90E5C86-A253-4431-AA3E-8AB652364367}"/>
          </ac:spMkLst>
        </pc:spChg>
        <pc:grpChg chg="add mod">
          <ac:chgData name="Padmanabh Singh" userId="5297dd9de2051429" providerId="LiveId" clId="{1E5F8D0C-68C3-4FC1-9B69-5B1D82998A2D}" dt="2023-12-15T00:29:31.670" v="144" actId="1076"/>
          <ac:grpSpMkLst>
            <pc:docMk/>
            <pc:sldMk cId="1797960873" sldId="263"/>
            <ac:grpSpMk id="5" creationId="{4E7A6391-1052-46F4-B5E4-5401D370D578}"/>
          </ac:grpSpMkLst>
        </pc:grpChg>
        <pc:graphicFrameChg chg="add del mod">
          <ac:chgData name="Padmanabh Singh" userId="5297dd9de2051429" providerId="LiveId" clId="{1E5F8D0C-68C3-4FC1-9B69-5B1D82998A2D}" dt="2023-12-14T22:21:34.514" v="86" actId="478"/>
          <ac:graphicFrameMkLst>
            <pc:docMk/>
            <pc:sldMk cId="1797960873" sldId="263"/>
            <ac:graphicFrameMk id="2" creationId="{A764E3C4-AA8F-4852-8669-C8220C1BE78B}"/>
          </ac:graphicFrameMkLst>
        </pc:graphicFrameChg>
        <pc:graphicFrameChg chg="add mod">
          <ac:chgData name="Padmanabh Singh" userId="5297dd9de2051429" providerId="LiveId" clId="{1E5F8D0C-68C3-4FC1-9B69-5B1D82998A2D}" dt="2023-12-15T00:29:19.920" v="142" actId="1076"/>
          <ac:graphicFrameMkLst>
            <pc:docMk/>
            <pc:sldMk cId="1797960873" sldId="263"/>
            <ac:graphicFrameMk id="3" creationId="{62C9741A-EDDE-45D9-ACC8-62BAC47ADDE7}"/>
          </ac:graphicFrameMkLst>
        </pc:graphicFrameChg>
        <pc:graphicFrameChg chg="add mod">
          <ac:chgData name="Padmanabh Singh" userId="5297dd9de2051429" providerId="LiveId" clId="{1E5F8D0C-68C3-4FC1-9B69-5B1D82998A2D}" dt="2023-12-15T00:29:14.124" v="141" actId="1076"/>
          <ac:graphicFrameMkLst>
            <pc:docMk/>
            <pc:sldMk cId="1797960873" sldId="263"/>
            <ac:graphicFrameMk id="4" creationId="{7FEBC894-789B-4891-83A4-1753EF16B086}"/>
          </ac:graphicFrameMkLst>
        </pc:graphicFrameChg>
        <pc:picChg chg="mod">
          <ac:chgData name="Padmanabh Singh" userId="5297dd9de2051429" providerId="LiveId" clId="{1E5F8D0C-68C3-4FC1-9B69-5B1D82998A2D}" dt="2023-12-15T00:29:27.826" v="143"/>
          <ac:picMkLst>
            <pc:docMk/>
            <pc:sldMk cId="1797960873" sldId="263"/>
            <ac:picMk id="6" creationId="{B398376B-267A-4243-906F-D7DF50AFCCA0}"/>
          </ac:picMkLst>
        </pc:picChg>
      </pc:sldChg>
      <pc:sldChg chg="addSp delSp modSp add del mod ord">
        <pc:chgData name="Padmanabh Singh" userId="5297dd9de2051429" providerId="LiveId" clId="{1E5F8D0C-68C3-4FC1-9B69-5B1D82998A2D}" dt="2023-12-15T06:14:43.260" v="322" actId="47"/>
        <pc:sldMkLst>
          <pc:docMk/>
          <pc:sldMk cId="1446623840" sldId="264"/>
        </pc:sldMkLst>
        <pc:spChg chg="add del mod">
          <ac:chgData name="Padmanabh Singh" userId="5297dd9de2051429" providerId="LiveId" clId="{1E5F8D0C-68C3-4FC1-9B69-5B1D82998A2D}" dt="2023-12-15T00:29:58.980" v="148"/>
          <ac:spMkLst>
            <pc:docMk/>
            <pc:sldMk cId="1446623840" sldId="264"/>
            <ac:spMk id="3" creationId="{A2EF492B-D4C1-4B6E-994A-EA7C2CD6B19F}"/>
          </ac:spMkLst>
        </pc:spChg>
        <pc:spChg chg="add mod">
          <ac:chgData name="Padmanabh Singh" userId="5297dd9de2051429" providerId="LiveId" clId="{1E5F8D0C-68C3-4FC1-9B69-5B1D82998A2D}" dt="2023-12-15T06:09:37.429" v="189" actId="20577"/>
          <ac:spMkLst>
            <pc:docMk/>
            <pc:sldMk cId="1446623840" sldId="264"/>
            <ac:spMk id="4" creationId="{B6C4B673-BC7B-423E-846B-5A5FFA6B94E4}"/>
          </ac:spMkLst>
        </pc:spChg>
        <pc:graphicFrameChg chg="add mod">
          <ac:chgData name="Padmanabh Singh" userId="5297dd9de2051429" providerId="LiveId" clId="{1E5F8D0C-68C3-4FC1-9B69-5B1D82998A2D}" dt="2023-12-14T22:23:58.526" v="92" actId="1076"/>
          <ac:graphicFrameMkLst>
            <pc:docMk/>
            <pc:sldMk cId="1446623840" sldId="264"/>
            <ac:graphicFrameMk id="2" creationId="{D9797B59-AB07-4C94-8DCA-7EC95274FE6E}"/>
          </ac:graphicFrameMkLst>
        </pc:graphicFrameChg>
      </pc:sldChg>
      <pc:sldChg chg="addSp delSp modSp add mod ord">
        <pc:chgData name="Padmanabh Singh" userId="5297dd9de2051429" providerId="LiveId" clId="{1E5F8D0C-68C3-4FC1-9B69-5B1D82998A2D}" dt="2023-12-15T06:31:15.587" v="621" actId="1076"/>
        <pc:sldMkLst>
          <pc:docMk/>
          <pc:sldMk cId="4014045831" sldId="265"/>
        </pc:sldMkLst>
        <pc:spChg chg="add del mod">
          <ac:chgData name="Padmanabh Singh" userId="5297dd9de2051429" providerId="LiveId" clId="{1E5F8D0C-68C3-4FC1-9B69-5B1D82998A2D}" dt="2023-12-15T06:17:06.860" v="368" actId="478"/>
          <ac:spMkLst>
            <pc:docMk/>
            <pc:sldMk cId="4014045831" sldId="265"/>
            <ac:spMk id="5" creationId="{77670808-35F2-47D5-848D-F810AD0CE266}"/>
          </ac:spMkLst>
        </pc:spChg>
        <pc:spChg chg="add mod">
          <ac:chgData name="Padmanabh Singh" userId="5297dd9de2051429" providerId="LiveId" clId="{1E5F8D0C-68C3-4FC1-9B69-5B1D82998A2D}" dt="2023-12-15T06:31:15.587" v="621" actId="1076"/>
          <ac:spMkLst>
            <pc:docMk/>
            <pc:sldMk cId="4014045831" sldId="265"/>
            <ac:spMk id="6" creationId="{5A2B15C0-957D-48DD-8E9F-0D194C4947EA}"/>
          </ac:spMkLst>
        </pc:spChg>
        <pc:spChg chg="add mod">
          <ac:chgData name="Padmanabh Singh" userId="5297dd9de2051429" providerId="LiveId" clId="{1E5F8D0C-68C3-4FC1-9B69-5B1D82998A2D}" dt="2023-12-15T06:31:08.197" v="620" actId="20577"/>
          <ac:spMkLst>
            <pc:docMk/>
            <pc:sldMk cId="4014045831" sldId="265"/>
            <ac:spMk id="7" creationId="{2E5463AD-42CC-48AC-A4A9-D94572605141}"/>
          </ac:spMkLst>
        </pc:spChg>
        <pc:graphicFrameChg chg="add mod">
          <ac:chgData name="Padmanabh Singh" userId="5297dd9de2051429" providerId="LiveId" clId="{1E5F8D0C-68C3-4FC1-9B69-5B1D82998A2D}" dt="2023-12-14T22:24:55.204" v="99" actId="1076"/>
          <ac:graphicFrameMkLst>
            <pc:docMk/>
            <pc:sldMk cId="4014045831" sldId="265"/>
            <ac:graphicFrameMk id="2" creationId="{9F6DE63F-6592-46D6-8FEF-716C31B31410}"/>
          </ac:graphicFrameMkLst>
        </pc:graphicFrameChg>
        <pc:graphicFrameChg chg="add mod">
          <ac:chgData name="Padmanabh Singh" userId="5297dd9de2051429" providerId="LiveId" clId="{1E5F8D0C-68C3-4FC1-9B69-5B1D82998A2D}" dt="2023-12-14T22:24:58.188" v="100" actId="1076"/>
          <ac:graphicFrameMkLst>
            <pc:docMk/>
            <pc:sldMk cId="4014045831" sldId="265"/>
            <ac:graphicFrameMk id="3" creationId="{93F5BF58-9A2B-4BC4-8E47-CDEF3D64B162}"/>
          </ac:graphicFrameMkLst>
        </pc:graphicFrameChg>
        <pc:graphicFrameChg chg="add mod">
          <ac:chgData name="Padmanabh Singh" userId="5297dd9de2051429" providerId="LiveId" clId="{1E5F8D0C-68C3-4FC1-9B69-5B1D82998A2D}" dt="2023-12-14T22:25:02.843" v="101" actId="1076"/>
          <ac:graphicFrameMkLst>
            <pc:docMk/>
            <pc:sldMk cId="4014045831" sldId="265"/>
            <ac:graphicFrameMk id="4" creationId="{ADD87D90-B6E3-4C28-851D-E192447D3565}"/>
          </ac:graphicFrameMkLst>
        </pc:graphicFrameChg>
      </pc:sldChg>
      <pc:sldChg chg="addSp modSp add mod ord">
        <pc:chgData name="Padmanabh Singh" userId="5297dd9de2051429" providerId="LiveId" clId="{1E5F8D0C-68C3-4FC1-9B69-5B1D82998A2D}" dt="2023-12-15T06:33:30.746" v="653"/>
        <pc:sldMkLst>
          <pc:docMk/>
          <pc:sldMk cId="2026924125" sldId="266"/>
        </pc:sldMkLst>
        <pc:spChg chg="add mod">
          <ac:chgData name="Padmanabh Singh" userId="5297dd9de2051429" providerId="LiveId" clId="{1E5F8D0C-68C3-4FC1-9B69-5B1D82998A2D}" dt="2023-12-15T06:33:22.088" v="652" actId="1076"/>
          <ac:spMkLst>
            <pc:docMk/>
            <pc:sldMk cId="2026924125" sldId="266"/>
            <ac:spMk id="4" creationId="{82780ADE-15C5-47BA-BA58-B257E309BBED}"/>
          </ac:spMkLst>
        </pc:spChg>
        <pc:spChg chg="add mod">
          <ac:chgData name="Padmanabh Singh" userId="5297dd9de2051429" providerId="LiveId" clId="{1E5F8D0C-68C3-4FC1-9B69-5B1D82998A2D}" dt="2023-12-15T06:33:30.746" v="653"/>
          <ac:spMkLst>
            <pc:docMk/>
            <pc:sldMk cId="2026924125" sldId="266"/>
            <ac:spMk id="5" creationId="{4CD5E645-04A4-44AB-A1DA-50B24E371798}"/>
          </ac:spMkLst>
        </pc:spChg>
        <pc:graphicFrameChg chg="add mod">
          <ac:chgData name="Padmanabh Singh" userId="5297dd9de2051429" providerId="LiveId" clId="{1E5F8D0C-68C3-4FC1-9B69-5B1D82998A2D}" dt="2023-12-14T22:25:51.143" v="106" actId="1076"/>
          <ac:graphicFrameMkLst>
            <pc:docMk/>
            <pc:sldMk cId="2026924125" sldId="266"/>
            <ac:graphicFrameMk id="2" creationId="{FE85CB95-8BF8-4A65-9FB5-67E46D7197EB}"/>
          </ac:graphicFrameMkLst>
        </pc:graphicFrameChg>
        <pc:graphicFrameChg chg="add mod">
          <ac:chgData name="Padmanabh Singh" userId="5297dd9de2051429" providerId="LiveId" clId="{1E5F8D0C-68C3-4FC1-9B69-5B1D82998A2D}" dt="2023-12-14T22:25:51.143" v="106" actId="1076"/>
          <ac:graphicFrameMkLst>
            <pc:docMk/>
            <pc:sldMk cId="2026924125" sldId="266"/>
            <ac:graphicFrameMk id="3" creationId="{EE1F8682-B8AC-46B7-80EB-6809A3B1B17D}"/>
          </ac:graphicFrameMkLst>
        </pc:graphicFrameChg>
      </pc:sldChg>
      <pc:sldChg chg="addSp modSp add mod">
        <pc:chgData name="Padmanabh Singh" userId="5297dd9de2051429" providerId="LiveId" clId="{1E5F8D0C-68C3-4FC1-9B69-5B1D82998A2D}" dt="2023-12-15T06:34:56.085" v="675" actId="1076"/>
        <pc:sldMkLst>
          <pc:docMk/>
          <pc:sldMk cId="881882750" sldId="267"/>
        </pc:sldMkLst>
        <pc:spChg chg="mod">
          <ac:chgData name="Padmanabh Singh" userId="5297dd9de2051429" providerId="LiveId" clId="{1E5F8D0C-68C3-4FC1-9B69-5B1D82998A2D}" dt="2023-12-15T00:31:21.922" v="158"/>
          <ac:spMkLst>
            <pc:docMk/>
            <pc:sldMk cId="881882750" sldId="267"/>
            <ac:spMk id="5" creationId="{C7DBDCD3-DA45-4A7D-B8CA-D9B1C7E5F4F2}"/>
          </ac:spMkLst>
        </pc:spChg>
        <pc:spChg chg="mod">
          <ac:chgData name="Padmanabh Singh" userId="5297dd9de2051429" providerId="LiveId" clId="{1E5F8D0C-68C3-4FC1-9B69-5B1D82998A2D}" dt="2023-12-15T00:31:21.922" v="158"/>
          <ac:spMkLst>
            <pc:docMk/>
            <pc:sldMk cId="881882750" sldId="267"/>
            <ac:spMk id="6" creationId="{C3051519-9CB2-4292-8A28-FF93EBD037A2}"/>
          </ac:spMkLst>
        </pc:spChg>
        <pc:spChg chg="mod">
          <ac:chgData name="Padmanabh Singh" userId="5297dd9de2051429" providerId="LiveId" clId="{1E5F8D0C-68C3-4FC1-9B69-5B1D82998A2D}" dt="2023-12-15T00:31:21.922" v="158"/>
          <ac:spMkLst>
            <pc:docMk/>
            <pc:sldMk cId="881882750" sldId="267"/>
            <ac:spMk id="7" creationId="{3E3FB2BD-9BE2-4350-8B26-4D92D049B952}"/>
          </ac:spMkLst>
        </pc:spChg>
        <pc:spChg chg="mod">
          <ac:chgData name="Padmanabh Singh" userId="5297dd9de2051429" providerId="LiveId" clId="{1E5F8D0C-68C3-4FC1-9B69-5B1D82998A2D}" dt="2023-12-15T00:31:21.922" v="158"/>
          <ac:spMkLst>
            <pc:docMk/>
            <pc:sldMk cId="881882750" sldId="267"/>
            <ac:spMk id="8" creationId="{44C074E0-8F4D-43BE-97AA-D232AD3D2475}"/>
          </ac:spMkLst>
        </pc:spChg>
        <pc:spChg chg="mod">
          <ac:chgData name="Padmanabh Singh" userId="5297dd9de2051429" providerId="LiveId" clId="{1E5F8D0C-68C3-4FC1-9B69-5B1D82998A2D}" dt="2023-12-15T00:31:21.922" v="158"/>
          <ac:spMkLst>
            <pc:docMk/>
            <pc:sldMk cId="881882750" sldId="267"/>
            <ac:spMk id="9" creationId="{92C99886-497C-4D97-B8B8-3A9954FD21AF}"/>
          </ac:spMkLst>
        </pc:spChg>
        <pc:spChg chg="add mod">
          <ac:chgData name="Padmanabh Singh" userId="5297dd9de2051429" providerId="LiveId" clId="{1E5F8D0C-68C3-4FC1-9B69-5B1D82998A2D}" dt="2023-12-15T06:34:49.117" v="673" actId="1076"/>
          <ac:spMkLst>
            <pc:docMk/>
            <pc:sldMk cId="881882750" sldId="267"/>
            <ac:spMk id="11" creationId="{17EC4664-3768-4979-A4F7-A1BC9CF614C7}"/>
          </ac:spMkLst>
        </pc:spChg>
        <pc:spChg chg="add mod">
          <ac:chgData name="Padmanabh Singh" userId="5297dd9de2051429" providerId="LiveId" clId="{1E5F8D0C-68C3-4FC1-9B69-5B1D82998A2D}" dt="2023-12-15T06:34:56.085" v="675" actId="1076"/>
          <ac:spMkLst>
            <pc:docMk/>
            <pc:sldMk cId="881882750" sldId="267"/>
            <ac:spMk id="12" creationId="{6AD84A61-802F-4B2D-AB5F-17902464BAFA}"/>
          </ac:spMkLst>
        </pc:spChg>
        <pc:grpChg chg="add mod">
          <ac:chgData name="Padmanabh Singh" userId="5297dd9de2051429" providerId="LiveId" clId="{1E5F8D0C-68C3-4FC1-9B69-5B1D82998A2D}" dt="2023-12-15T00:31:58.408" v="178" actId="1038"/>
          <ac:grpSpMkLst>
            <pc:docMk/>
            <pc:sldMk cId="881882750" sldId="267"/>
            <ac:grpSpMk id="4" creationId="{8500D4E0-140C-4870-AAFC-80B82724A190}"/>
          </ac:grpSpMkLst>
        </pc:grpChg>
        <pc:graphicFrameChg chg="add mod">
          <ac:chgData name="Padmanabh Singh" userId="5297dd9de2051429" providerId="LiveId" clId="{1E5F8D0C-68C3-4FC1-9B69-5B1D82998A2D}" dt="2023-12-15T00:31:51.032" v="169" actId="1076"/>
          <ac:graphicFrameMkLst>
            <pc:docMk/>
            <pc:sldMk cId="881882750" sldId="267"/>
            <ac:graphicFrameMk id="2" creationId="{055AE9C7-F920-43AF-BAC3-B0EFFB5F33A0}"/>
          </ac:graphicFrameMkLst>
        </pc:graphicFrameChg>
        <pc:graphicFrameChg chg="add mod">
          <ac:chgData name="Padmanabh Singh" userId="5297dd9de2051429" providerId="LiveId" clId="{1E5F8D0C-68C3-4FC1-9B69-5B1D82998A2D}" dt="2023-12-15T00:31:33.017" v="163" actId="1076"/>
          <ac:graphicFrameMkLst>
            <pc:docMk/>
            <pc:sldMk cId="881882750" sldId="267"/>
            <ac:graphicFrameMk id="3" creationId="{570BFADA-1143-4849-B1AC-0918C020A635}"/>
          </ac:graphicFrameMkLst>
        </pc:graphicFrameChg>
        <pc:picChg chg="mod">
          <ac:chgData name="Padmanabh Singh" userId="5297dd9de2051429" providerId="LiveId" clId="{1E5F8D0C-68C3-4FC1-9B69-5B1D82998A2D}" dt="2023-12-15T00:31:21.922" v="158"/>
          <ac:picMkLst>
            <pc:docMk/>
            <pc:sldMk cId="881882750" sldId="267"/>
            <ac:picMk id="10" creationId="{43D58195-6E97-4770-A398-BA813B4904F7}"/>
          </ac:picMkLst>
        </pc:picChg>
      </pc:sldChg>
      <pc:sldChg chg="add del">
        <pc:chgData name="Padmanabh Singh" userId="5297dd9de2051429" providerId="LiveId" clId="{1E5F8D0C-68C3-4FC1-9B69-5B1D82998A2D}" dt="2023-12-15T00:32:41.874" v="180" actId="47"/>
        <pc:sldMkLst>
          <pc:docMk/>
          <pc:sldMk cId="1517510249" sldId="268"/>
        </pc:sldMkLst>
      </pc:sldChg>
      <pc:sldChg chg="delSp modSp add mod">
        <pc:chgData name="Padmanabh Singh" userId="5297dd9de2051429" providerId="LiveId" clId="{1E5F8D0C-68C3-4FC1-9B69-5B1D82998A2D}" dt="2023-12-15T06:35:01.194" v="676" actId="20577"/>
        <pc:sldMkLst>
          <pc:docMk/>
          <pc:sldMk cId="2522756235" sldId="287"/>
        </pc:sldMkLst>
        <pc:spChg chg="mod">
          <ac:chgData name="Padmanabh Singh" userId="5297dd9de2051429" providerId="LiveId" clId="{1E5F8D0C-68C3-4FC1-9B69-5B1D82998A2D}" dt="2023-12-15T06:35:01.194" v="676" actId="20577"/>
          <ac:spMkLst>
            <pc:docMk/>
            <pc:sldMk cId="2522756235" sldId="287"/>
            <ac:spMk id="2" creationId="{B905FFF7-C9DD-484D-AD91-511CD10B8089}"/>
          </ac:spMkLst>
        </pc:spChg>
        <pc:spChg chg="del">
          <ac:chgData name="Padmanabh Singh" userId="5297dd9de2051429" providerId="LiveId" clId="{1E5F8D0C-68C3-4FC1-9B69-5B1D82998A2D}" dt="2023-12-15T00:59:28.521" v="183" actId="478"/>
          <ac:spMkLst>
            <pc:docMk/>
            <pc:sldMk cId="2522756235" sldId="287"/>
            <ac:spMk id="4" creationId="{1241D9D1-1E94-46DC-B586-EF81E8EE0695}"/>
          </ac:spMkLst>
        </pc:spChg>
      </pc:sldChg>
      <pc:sldChg chg="delSp modSp add mod">
        <pc:chgData name="Padmanabh Singh" userId="5297dd9de2051429" providerId="LiveId" clId="{1E5F8D0C-68C3-4FC1-9B69-5B1D82998A2D}" dt="2023-12-15T06:35:04.413" v="677" actId="20577"/>
        <pc:sldMkLst>
          <pc:docMk/>
          <pc:sldMk cId="3244116327" sldId="297"/>
        </pc:sldMkLst>
        <pc:spChg chg="mod">
          <ac:chgData name="Padmanabh Singh" userId="5297dd9de2051429" providerId="LiveId" clId="{1E5F8D0C-68C3-4FC1-9B69-5B1D82998A2D}" dt="2023-12-15T06:35:04.413" v="677" actId="20577"/>
          <ac:spMkLst>
            <pc:docMk/>
            <pc:sldMk cId="3244116327" sldId="297"/>
            <ac:spMk id="6" creationId="{6E71E4C3-F7F8-4393-B844-887EF6311469}"/>
          </ac:spMkLst>
        </pc:spChg>
        <pc:spChg chg="del">
          <ac:chgData name="Padmanabh Singh" userId="5297dd9de2051429" providerId="LiveId" clId="{1E5F8D0C-68C3-4FC1-9B69-5B1D82998A2D}" dt="2023-12-15T00:59:26.553" v="182" actId="478"/>
          <ac:spMkLst>
            <pc:docMk/>
            <pc:sldMk cId="3244116327" sldId="297"/>
            <ac:spMk id="18" creationId="{B5369C1C-59E3-4ABD-81BE-1795436592E6}"/>
          </ac:spMkLst>
        </pc:spChg>
      </pc:sldChg>
      <pc:sldChg chg="delSp modSp add mod">
        <pc:chgData name="Padmanabh Singh" userId="5297dd9de2051429" providerId="LiveId" clId="{1E5F8D0C-68C3-4FC1-9B69-5B1D82998A2D}" dt="2023-12-15T06:35:07.537" v="678" actId="20577"/>
        <pc:sldMkLst>
          <pc:docMk/>
          <pc:sldMk cId="623573729" sldId="308"/>
        </pc:sldMkLst>
        <pc:spChg chg="mod">
          <ac:chgData name="Padmanabh Singh" userId="5297dd9de2051429" providerId="LiveId" clId="{1E5F8D0C-68C3-4FC1-9B69-5B1D82998A2D}" dt="2023-12-15T06:35:07.537" v="678" actId="20577"/>
          <ac:spMkLst>
            <pc:docMk/>
            <pc:sldMk cId="623573729" sldId="308"/>
            <ac:spMk id="5" creationId="{4864DF4C-EE24-4186-87F5-BF32970C0585}"/>
          </ac:spMkLst>
        </pc:spChg>
        <pc:spChg chg="del">
          <ac:chgData name="Padmanabh Singh" userId="5297dd9de2051429" providerId="LiveId" clId="{1E5F8D0C-68C3-4FC1-9B69-5B1D82998A2D}" dt="2023-12-15T00:59:24.660" v="181" actId="478"/>
          <ac:spMkLst>
            <pc:docMk/>
            <pc:sldMk cId="623573729" sldId="308"/>
            <ac:spMk id="12" creationId="{BEA8A7A8-447E-40B4-B10C-FF7EDE6C8FA7}"/>
          </ac:spMkLst>
        </pc:spChg>
      </pc:sldChg>
      <pc:sldMasterChg chg="addSldLayout">
        <pc:chgData name="Padmanabh Singh" userId="5297dd9de2051429" providerId="LiveId" clId="{1E5F8D0C-68C3-4FC1-9B69-5B1D82998A2D}" dt="2023-12-14T08:04:03.028" v="0" actId="680"/>
        <pc:sldMasterMkLst>
          <pc:docMk/>
          <pc:sldMasterMk cId="1836463899" sldId="2147483648"/>
        </pc:sldMasterMkLst>
        <pc:sldLayoutChg chg="add">
          <pc:chgData name="Padmanabh Singh" userId="5297dd9de2051429" providerId="LiveId" clId="{1E5F8D0C-68C3-4FC1-9B69-5B1D82998A2D}" dt="2023-12-14T08:04:03.028" v="0" actId="680"/>
          <pc:sldLayoutMkLst>
            <pc:docMk/>
            <pc:sldMasterMk cId="1836463899" sldId="2147483648"/>
            <pc:sldLayoutMk cId="1367979396" sldId="2147483649"/>
          </pc:sldLayoutMkLst>
        </pc:sldLayoutChg>
      </pc:sldMasterChg>
    </pc:docChg>
  </pc:docChgLst>
</pc:chgInfo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732FF91-D9C5-4818-A0CA-71FC99B0EF8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53870EB7-2541-43B8-AE8D-D641778920D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</p:spTree>
    <p:extLst>
      <p:ext uri="{BB962C8B-B14F-4D97-AF65-F5344CB8AC3E}">
        <p14:creationId xmlns:p14="http://schemas.microsoft.com/office/powerpoint/2010/main" val="13679793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F13D2C-A9A2-4C33-B07C-F7A0BE25C66B}" type="datetimeFigureOut">
              <a:rPr lang="ko-KR" altLang="en-US" smtClean="0"/>
              <a:pPr/>
              <a:t>2024-04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812DD-AF73-4A48-AB42-2A395192A18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5645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8364638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="" xmlns:a16="http://schemas.microsoft.com/office/drawing/2014/main" id="{EA360F17-CD36-4F80-9618-BE6D018EBFE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8541592"/>
              </p:ext>
            </p:extLst>
          </p:nvPr>
        </p:nvGraphicFramePr>
        <p:xfrm>
          <a:off x="455613" y="1119188"/>
          <a:ext cx="3929062" cy="4219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812" name="Prism 8" r:id="rId3" imgW="3928721" imgH="4220285" progId="Prism8.Document">
                  <p:embed/>
                </p:oleObj>
              </mc:Choice>
              <mc:Fallback>
                <p:oleObj name="Prism 8" r:id="rId3" imgW="3928721" imgH="422028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55613" y="1119188"/>
                        <a:ext cx="3929062" cy="4219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="" xmlns:a16="http://schemas.microsoft.com/office/drawing/2014/main" id="{B905FFF7-C9DD-484D-AD91-511CD10B8089}"/>
              </a:ext>
            </a:extLst>
          </p:cNvPr>
          <p:cNvSpPr txBox="1"/>
          <p:nvPr/>
        </p:nvSpPr>
        <p:spPr>
          <a:xfrm>
            <a:off x="715559" y="6032792"/>
            <a:ext cx="39917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Supplemental Fig. 1. </a:t>
            </a:r>
            <a:r>
              <a:rPr lang="en-US" altLang="ko-KR" sz="16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Changes</a:t>
            </a:r>
            <a:r>
              <a:rPr lang="ko-KR" altLang="en-US" sz="16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 </a:t>
            </a:r>
            <a:r>
              <a:rPr lang="en-US" altLang="ko-KR" sz="16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in body weight</a:t>
            </a:r>
            <a:r>
              <a:rPr lang="en-US" sz="16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.</a:t>
            </a:r>
            <a:endParaRPr lang="en-US" sz="1600" dirty="0">
              <a:latin typeface="Times New Roman" panose="02020603050405020304" pitchFamily="18" charset="0"/>
              <a:ea typeface="Tahoma" panose="020B060403050404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Object 5">
            <a:extLst>
              <a:ext uri="{FF2B5EF4-FFF2-40B4-BE49-F238E27FC236}">
                <a16:creationId xmlns="" xmlns:a16="http://schemas.microsoft.com/office/drawing/2014/main" id="{02E6D997-70E3-4834-8661-2DBAABB6E1B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10932273"/>
              </p:ext>
            </p:extLst>
          </p:nvPr>
        </p:nvGraphicFramePr>
        <p:xfrm>
          <a:off x="3932238" y="1416050"/>
          <a:ext cx="3929062" cy="3924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813" name="Prism 8" r:id="rId5" imgW="3928721" imgH="3924599" progId="Prism8.Document">
                  <p:embed/>
                </p:oleObj>
              </mc:Choice>
              <mc:Fallback>
                <p:oleObj name="Prism 8" r:id="rId5" imgW="3928721" imgH="392459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32238" y="1416050"/>
                        <a:ext cx="3929062" cy="3924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6">
            <a:extLst>
              <a:ext uri="{FF2B5EF4-FFF2-40B4-BE49-F238E27FC236}">
                <a16:creationId xmlns="" xmlns:a16="http://schemas.microsoft.com/office/drawing/2014/main" id="{7D2256B6-2341-4391-8975-E37F4663E99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57287709"/>
              </p:ext>
            </p:extLst>
          </p:nvPr>
        </p:nvGraphicFramePr>
        <p:xfrm>
          <a:off x="7745413" y="1181100"/>
          <a:ext cx="4108450" cy="4098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814" name="Prism 8" r:id="rId7" imgW="4241318" imgH="4235412" progId="Prism8.Document">
                  <p:embed/>
                </p:oleObj>
              </mc:Choice>
              <mc:Fallback>
                <p:oleObj name="Prism 8" r:id="rId7" imgW="4241318" imgH="423541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745413" y="1181100"/>
                        <a:ext cx="4108450" cy="4098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530252" y="2063818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 smtClean="0"/>
              <a:t>A</a:t>
            </a:r>
            <a:endParaRPr lang="ko-KR" altLang="en-US" sz="24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4046714" y="2063818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 smtClean="0"/>
              <a:t>B</a:t>
            </a:r>
            <a:endParaRPr lang="ko-KR" altLang="en-US" sz="2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7556764" y="2063818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 smtClean="0"/>
              <a:t>C</a:t>
            </a:r>
            <a:endParaRPr lang="ko-KR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12197685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442C100A-6320-4D83-A5F2-8ED1936127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5629" y="734725"/>
            <a:ext cx="8804992" cy="409114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B905FFF7-C9DD-484D-AD91-511CD10B8089}"/>
              </a:ext>
            </a:extLst>
          </p:cNvPr>
          <p:cNvSpPr txBox="1"/>
          <p:nvPr/>
        </p:nvSpPr>
        <p:spPr>
          <a:xfrm>
            <a:off x="913267" y="5299624"/>
            <a:ext cx="107169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Supplemental Fig. 2A. </a:t>
            </a:r>
            <a:r>
              <a:rPr lang="en-US" sz="16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Representative TTC-stained brain sections of Sham-operated and tMCAO rats </a:t>
            </a:r>
            <a:r>
              <a:rPr lang="en-US" sz="16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an day 10 post injury</a:t>
            </a:r>
            <a:r>
              <a:rPr lang="en-US" sz="16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A94802D8-E715-40BA-A1F2-E6652AE5B8EC}"/>
              </a:ext>
            </a:extLst>
          </p:cNvPr>
          <p:cNvSpPr txBox="1"/>
          <p:nvPr/>
        </p:nvSpPr>
        <p:spPr>
          <a:xfrm>
            <a:off x="4856045" y="841771"/>
            <a:ext cx="739305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m contro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="" xmlns:a16="http://schemas.microsoft.com/office/drawing/2014/main" id="{ECB5B728-516F-4E2C-A5AC-66031A80D4C2}"/>
              </a:ext>
            </a:extLst>
          </p:cNvPr>
          <p:cNvSpPr txBox="1"/>
          <p:nvPr/>
        </p:nvSpPr>
        <p:spPr>
          <a:xfrm>
            <a:off x="5756228" y="857835"/>
            <a:ext cx="837089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CAO contro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="" xmlns:a16="http://schemas.microsoft.com/office/drawing/2014/main" id="{D88DD88F-1ED0-4CF5-B8D0-1491F526F39B}"/>
              </a:ext>
            </a:extLst>
          </p:cNvPr>
          <p:cNvSpPr txBox="1"/>
          <p:nvPr/>
        </p:nvSpPr>
        <p:spPr>
          <a:xfrm>
            <a:off x="6514543" y="718661"/>
            <a:ext cx="1090363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odenafil 0.5mg/kg</a:t>
            </a:r>
          </a:p>
          <a:p>
            <a:pPr algn="ctr"/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ed rat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="" xmlns:a16="http://schemas.microsoft.com/office/drawing/2014/main" id="{5B7B249D-F9BB-43EC-97CB-208859665EAB}"/>
              </a:ext>
            </a:extLst>
          </p:cNvPr>
          <p:cNvSpPr txBox="1"/>
          <p:nvPr/>
        </p:nvSpPr>
        <p:spPr>
          <a:xfrm>
            <a:off x="7503256" y="726693"/>
            <a:ext cx="1090363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odenafil 1mg/kg</a:t>
            </a:r>
          </a:p>
          <a:p>
            <a:pPr algn="ctr"/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ed rat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="" xmlns:a16="http://schemas.microsoft.com/office/drawing/2014/main" id="{D4334B1B-D2A4-487B-A8FC-2CC1FD5D41BE}"/>
              </a:ext>
            </a:extLst>
          </p:cNvPr>
          <p:cNvSpPr txBox="1"/>
          <p:nvPr/>
        </p:nvSpPr>
        <p:spPr>
          <a:xfrm>
            <a:off x="8593619" y="688558"/>
            <a:ext cx="1090363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odenafil 2mg/kg</a:t>
            </a:r>
          </a:p>
          <a:p>
            <a:pPr algn="ctr"/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ed rats</a:t>
            </a:r>
          </a:p>
        </p:txBody>
      </p:sp>
    </p:spTree>
    <p:extLst>
      <p:ext uri="{BB962C8B-B14F-4D97-AF65-F5344CB8AC3E}">
        <p14:creationId xmlns:p14="http://schemas.microsoft.com/office/powerpoint/2010/main" val="16188737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6E71E4C3-F7F8-4393-B844-887EF6311469}"/>
              </a:ext>
            </a:extLst>
          </p:cNvPr>
          <p:cNvSpPr txBox="1"/>
          <p:nvPr/>
        </p:nvSpPr>
        <p:spPr>
          <a:xfrm>
            <a:off x="812052" y="6179864"/>
            <a:ext cx="105374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Supplemental Fig. 2B. </a:t>
            </a:r>
            <a:r>
              <a:rPr lang="en-US" sz="16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Representative TTC-stained brain sections of Sham-operated and pMCAO rats </a:t>
            </a:r>
            <a:r>
              <a:rPr lang="en-US" sz="16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on day 29 post injury</a:t>
            </a:r>
            <a:r>
              <a:rPr lang="en-US" sz="16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="" xmlns:a16="http://schemas.microsoft.com/office/drawing/2014/main" id="{F3B06C7D-3401-4951-9B1A-F021881E8E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68396" y="1028492"/>
            <a:ext cx="8855207" cy="48010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45772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96</TotalTime>
  <Words>69</Words>
  <Application>Microsoft Office PowerPoint</Application>
  <PresentationFormat>와이드스크린</PresentationFormat>
  <Paragraphs>14</Paragraphs>
  <Slides>3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11" baseType="lpstr">
      <vt:lpstr>맑은 고딕</vt:lpstr>
      <vt:lpstr>Arial</vt:lpstr>
      <vt:lpstr>Calibri</vt:lpstr>
      <vt:lpstr>Calibri Light</vt:lpstr>
      <vt:lpstr>Tahoma</vt:lpstr>
      <vt:lpstr>Times New Roman</vt:lpstr>
      <vt:lpstr>Office Theme</vt:lpstr>
      <vt:lpstr>Prism 8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dmanabh Singh</dc:creator>
  <cp:lastModifiedBy>ASUS</cp:lastModifiedBy>
  <cp:revision>152</cp:revision>
  <dcterms:created xsi:type="dcterms:W3CDTF">2023-12-14T08:03:59Z</dcterms:created>
  <dcterms:modified xsi:type="dcterms:W3CDTF">2024-04-05T23:45:13Z</dcterms:modified>
</cp:coreProperties>
</file>